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59" r:id="rId2"/>
    <p:sldId id="261" r:id="rId3"/>
    <p:sldId id="265" r:id="rId4"/>
    <p:sldId id="268" r:id="rId5"/>
    <p:sldId id="269" r:id="rId6"/>
    <p:sldId id="270" r:id="rId7"/>
    <p:sldId id="271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98"/>
    <p:restoredTop sz="80846"/>
  </p:normalViewPr>
  <p:slideViewPr>
    <p:cSldViewPr snapToGrid="0">
      <p:cViewPr>
        <p:scale>
          <a:sx n="75" d="100"/>
          <a:sy n="75" d="100"/>
        </p:scale>
        <p:origin x="2910" y="-489"/>
      </p:cViewPr>
      <p:guideLst/>
    </p:cSldViewPr>
  </p:slideViewPr>
  <p:notesTextViewPr>
    <p:cViewPr>
      <p:scale>
        <a:sx n="140" d="100"/>
        <a:sy n="14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62037D-F4E7-7446-B980-BC0E8AC2D40E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946DE2-378B-A34E-9CB0-D3506A072DF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45476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1. The time course of the synthesis reaction under 5 mM Mg2+ in the presence of different concentrations of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nd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lys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, detected at the 1st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r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2nd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r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nd 3rd hr. 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and (B) The synthesis of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iBiT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ith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VT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a-tRNA (14.4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and native aa-tRNA (7.2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C) and (D) The synthesis of full-length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ith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VT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a-tRNA and native aa-tRNA.</a:t>
            </a:r>
            <a:endParaRPr lang="en" altLang="zh-CN" sz="1800" dirty="0">
              <a:effectLst/>
              <a:latin typeface="Times New Roman" panose="02020603050405020304" pitchFamily="18" charset="0"/>
            </a:endParaRPr>
          </a:p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946DE2-378B-A34E-9CB0-D3506A072DF1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712436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2. The time course of the synthesis of full-length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t different concentrations of Mg</a:t>
            </a:r>
            <a:r>
              <a:rPr lang="en" altLang="zh-CN" sz="1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in the absence or presence of 2.5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nd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lys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. 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The synthesis of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t 5 mM, 7 mM and 9 mM Mg</a:t>
            </a:r>
            <a:r>
              <a:rPr lang="en" altLang="zh-CN" sz="1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ith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VT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a-tRNAs, in the absence of eIF5A or the presence of (B) 2.5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nd (C)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lys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D) The synthesis of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t 5 mM, 7 mM and 9 mM Mg</a:t>
            </a:r>
            <a:r>
              <a:rPr lang="en" altLang="zh-CN" sz="1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ith native aa-tRNAs, in the absence of eIF5A or the presence of (E) 2.5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nd (F)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lys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.</a:t>
            </a:r>
            <a:endParaRPr lang="en" altLang="zh-CN" sz="1800" dirty="0">
              <a:effectLst/>
              <a:latin typeface="Times New Roman" panose="02020603050405020304" pitchFamily="18" charset="0"/>
            </a:endParaRPr>
          </a:p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946DE2-378B-A34E-9CB0-D3506A072DF1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613426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3. The time course of synthesis of full-length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ith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VT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a-tRNAs (14.4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the absence or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recenc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of different types of eIF5A (2.5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</a:t>
            </a:r>
            <a:r>
              <a:rPr lang="en" altLang="zh-CN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at 6 mM Mg</a:t>
            </a:r>
            <a:r>
              <a:rPr lang="en" altLang="zh-CN" sz="1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en" altLang="zh-CN" sz="1800" dirty="0">
              <a:effectLst/>
              <a:latin typeface="Times New Roman" panose="02020603050405020304" pitchFamily="18" charset="0"/>
            </a:endParaRPr>
          </a:p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946DE2-378B-A34E-9CB0-D3506A072DF1}" type="slidenum">
              <a:rPr kumimoji="1" lang="zh-CN" altLang="en-US" smtClean="0"/>
              <a:t>3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116325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4. The time courses of readthrough assays in Figure 8. The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were collected after 1.5hr and 3hr reaction. 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native aa-tRNAs (7.2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the absence of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5 mM Mg</a:t>
            </a:r>
            <a:r>
              <a:rPr lang="en" altLang="zh-CN" sz="1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B) without eRF1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C) The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native aa-tRNAs (7.2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presence of 2.5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5 mM Mg</a:t>
            </a:r>
            <a:r>
              <a:rPr lang="en" altLang="zh-CN" sz="1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D) without eRF1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E) The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native aa-tRNAs (7.2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the absence of 2.5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9 mM Mg</a:t>
            </a:r>
            <a:r>
              <a:rPr lang="en" altLang="zh-CN" sz="1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F) without eRF1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G) The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native aa-tRNAs (7.2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presence of 2.5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9 mM Mg</a:t>
            </a:r>
            <a:r>
              <a:rPr lang="en" altLang="zh-CN" sz="1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H) without eRF1. </a:t>
            </a:r>
            <a:endParaRPr lang="en" altLang="zh-CN" sz="1800" dirty="0">
              <a:effectLst/>
              <a:latin typeface="Times New Roman" panose="02020603050405020304" pitchFamily="18" charset="0"/>
            </a:endParaRPr>
          </a:p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946DE2-378B-A34E-9CB0-D3506A072DF1}" type="slidenum">
              <a:rPr kumimoji="1" lang="zh-CN" altLang="en-US" smtClean="0"/>
              <a:t>4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2177004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romanUcParenBoth"/>
              <a:tabLst/>
              <a:defRPr/>
            </a:pP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" altLang="zh-CN" sz="12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</a:t>
            </a:r>
            <a:r>
              <a:rPr lang="en" altLang="zh-CN" sz="12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VT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a-tRNAs (14.4 </a:t>
            </a:r>
            <a:r>
              <a:rPr lang="el-GR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presence of 2.5 </a:t>
            </a:r>
            <a:r>
              <a:rPr lang="el-GR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2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5 mM Mg</a:t>
            </a:r>
            <a:r>
              <a:rPr lang="en" altLang="zh-CN" sz="12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J) without eRF1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K) The </a:t>
            </a:r>
            <a:r>
              <a:rPr lang="en" altLang="zh-CN" sz="12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</a:t>
            </a:r>
            <a:r>
              <a:rPr lang="en" altLang="zh-CN" sz="12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VT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a-tRNAs (14.4 </a:t>
            </a:r>
            <a:r>
              <a:rPr lang="el-GR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absence of eIF5A (</a:t>
            </a:r>
            <a:r>
              <a:rPr lang="en" altLang="zh-CN" sz="12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9 mM Mg</a:t>
            </a:r>
            <a:r>
              <a:rPr lang="en" altLang="zh-CN" sz="12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L) without eRF1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M) The </a:t>
            </a:r>
            <a:r>
              <a:rPr lang="en" altLang="zh-CN" sz="12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</a:t>
            </a:r>
            <a:r>
              <a:rPr lang="en" altLang="zh-CN" sz="12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VT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a-tRNAs (</a:t>
            </a:r>
            <a:r>
              <a:rPr lang="el-GR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14.4 μ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presence of 2.5 </a:t>
            </a:r>
            <a:r>
              <a:rPr lang="el-GR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2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9 mM Mg</a:t>
            </a:r>
            <a:r>
              <a:rPr lang="en" altLang="zh-CN" sz="12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N) without eRF1. </a:t>
            </a:r>
            <a:endParaRPr lang="en" altLang="zh-CN" sz="1200" dirty="0">
              <a:effectLst/>
              <a:latin typeface="Times New Roman" panose="02020603050405020304" pitchFamily="18" charset="0"/>
            </a:endParaRPr>
          </a:p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946DE2-378B-A34E-9CB0-D3506A072DF1}" type="slidenum">
              <a:rPr kumimoji="1" lang="zh-CN" altLang="en-US" smtClean="0"/>
              <a:t>5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7435862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5. The correlation analysis of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with input mRNA amount and reaction time. The synthesis of full-length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as performed with different concentrations of input mRNA (0.2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, 0.5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and 1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, in the presence of eRF1. The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were detected after 1.5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r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nd 3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r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reaction. 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The synthesis of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ith native aa-tRNAs (7.2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, in the absence and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B) in the presence of 2.5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5 mM Mg</a:t>
            </a:r>
            <a:r>
              <a:rPr lang="en" altLang="zh-CN" sz="1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C) The synthesis of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ith native aa-tRNAs (7.2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, in the absence and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D) in the presence of 2.5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9 mM Mg</a:t>
            </a:r>
            <a:r>
              <a:rPr lang="en" altLang="zh-CN" sz="1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E) The synthesis of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ith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VT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a-tRNAs (14.4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, in the absence of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5 mM Mg</a:t>
            </a:r>
            <a:r>
              <a:rPr lang="en" altLang="zh-CN" sz="1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F) The synthesis of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ith 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VT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a-tRNAs (14.4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, in the absence and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G) in the presence of 2.5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8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9 mM Mg</a:t>
            </a:r>
            <a:r>
              <a:rPr lang="en" altLang="zh-CN" sz="1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en" altLang="zh-CN" sz="1800" dirty="0">
              <a:effectLst/>
              <a:latin typeface="Times New Roman" panose="02020603050405020304" pitchFamily="18" charset="0"/>
            </a:endParaRPr>
          </a:p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946DE2-378B-A34E-9CB0-D3506A072DF1}" type="slidenum">
              <a:rPr kumimoji="1" lang="zh-CN" altLang="en-US" smtClean="0"/>
              <a:t>6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395934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F4753-7ED6-EF49-84C0-83331D273632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A2D48-01C3-7E45-95D6-F2D474BBAAA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73199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F4753-7ED6-EF49-84C0-83331D273632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A2D48-01C3-7E45-95D6-F2D474BBAAA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35272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F4753-7ED6-EF49-84C0-83331D273632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A2D48-01C3-7E45-95D6-F2D474BBAAA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59885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F4753-7ED6-EF49-84C0-83331D273632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A2D48-01C3-7E45-95D6-F2D474BBAAA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99513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F4753-7ED6-EF49-84C0-83331D273632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A2D48-01C3-7E45-95D6-F2D474BBAAA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514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F4753-7ED6-EF49-84C0-83331D273632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A2D48-01C3-7E45-95D6-F2D474BBAAA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976290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F4753-7ED6-EF49-84C0-83331D273632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A2D48-01C3-7E45-95D6-F2D474BBAAA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91873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F4753-7ED6-EF49-84C0-83331D273632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A2D48-01C3-7E45-95D6-F2D474BBAAA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74471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F4753-7ED6-EF49-84C0-83331D273632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A2D48-01C3-7E45-95D6-F2D474BBAAA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21483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F4753-7ED6-EF49-84C0-83331D273632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A2D48-01C3-7E45-95D6-F2D474BBAAA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36010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F4753-7ED6-EF49-84C0-83331D273632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A2D48-01C3-7E45-95D6-F2D474BBAAA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48673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2F4753-7ED6-EF49-84C0-83331D273632}" type="datetimeFigureOut">
              <a:rPr kumimoji="1" lang="zh-CN" altLang="en-US" smtClean="0"/>
              <a:t>2025/9/1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7A2D48-01C3-7E45-95D6-F2D474BBAAA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63825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107">
            <a:extLst>
              <a:ext uri="{FF2B5EF4-FFF2-40B4-BE49-F238E27FC236}">
                <a16:creationId xmlns:a16="http://schemas.microsoft.com/office/drawing/2014/main" id="{A1410463-8C1C-AD68-47DD-7EFFB8BE168B}"/>
              </a:ext>
            </a:extLst>
          </p:cNvPr>
          <p:cNvSpPr/>
          <p:nvPr/>
        </p:nvSpPr>
        <p:spPr>
          <a:xfrm>
            <a:off x="162411" y="141527"/>
            <a:ext cx="28777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026BE0D0-03F0-B6DB-3D3D-3149105874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1922" y="688521"/>
            <a:ext cx="4554155" cy="2071007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45A9E18-5525-CF6F-F727-9DB278A2BE0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51922" y="2759528"/>
            <a:ext cx="4554155" cy="198996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5BCAD384-F322-F7A0-ACEC-021049F258E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51922" y="4953000"/>
            <a:ext cx="4357809" cy="1849588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3C8893C3-23C7-A938-C166-FF1218BB4C49}"/>
              </a:ext>
            </a:extLst>
          </p:cNvPr>
          <p:cNvSpPr txBox="1"/>
          <p:nvPr/>
        </p:nvSpPr>
        <p:spPr>
          <a:xfrm>
            <a:off x="792188" y="512032"/>
            <a:ext cx="37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320DEDE-6592-7657-CA43-9D1C2DEFEB6A}"/>
              </a:ext>
            </a:extLst>
          </p:cNvPr>
          <p:cNvSpPr txBox="1"/>
          <p:nvPr/>
        </p:nvSpPr>
        <p:spPr>
          <a:xfrm>
            <a:off x="767733" y="2547263"/>
            <a:ext cx="37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FE52E2D-4E37-3E19-656B-3B9CC6F440CE}"/>
              </a:ext>
            </a:extLst>
          </p:cNvPr>
          <p:cNvSpPr txBox="1"/>
          <p:nvPr/>
        </p:nvSpPr>
        <p:spPr>
          <a:xfrm>
            <a:off x="738511" y="4770229"/>
            <a:ext cx="37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609CC44-3E3A-EAC5-CB57-DE7BAA745F07}"/>
              </a:ext>
            </a:extLst>
          </p:cNvPr>
          <p:cNvSpPr txBox="1"/>
          <p:nvPr/>
        </p:nvSpPr>
        <p:spPr>
          <a:xfrm>
            <a:off x="767732" y="6599882"/>
            <a:ext cx="37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3364AA6-C888-AEF3-47E5-46AFECA171F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70131" y="7146472"/>
            <a:ext cx="4554155" cy="19234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4357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107">
            <a:extLst>
              <a:ext uri="{FF2B5EF4-FFF2-40B4-BE49-F238E27FC236}">
                <a16:creationId xmlns:a16="http://schemas.microsoft.com/office/drawing/2014/main" id="{B1A74A21-7758-BE37-3FC4-E692E7B31EEA}"/>
              </a:ext>
            </a:extLst>
          </p:cNvPr>
          <p:cNvSpPr/>
          <p:nvPr/>
        </p:nvSpPr>
        <p:spPr>
          <a:xfrm>
            <a:off x="162411" y="141527"/>
            <a:ext cx="28777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E541192-69B5-BA85-2518-75EC44B24A43}"/>
              </a:ext>
            </a:extLst>
          </p:cNvPr>
          <p:cNvSpPr txBox="1"/>
          <p:nvPr/>
        </p:nvSpPr>
        <p:spPr>
          <a:xfrm>
            <a:off x="0" y="520949"/>
            <a:ext cx="37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3B1288B-747E-D649-5BB1-460ED998DC04}"/>
              </a:ext>
            </a:extLst>
          </p:cNvPr>
          <p:cNvSpPr txBox="1"/>
          <p:nvPr/>
        </p:nvSpPr>
        <p:spPr>
          <a:xfrm>
            <a:off x="0" y="3405536"/>
            <a:ext cx="37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E5327BA-CE49-2953-F0A9-1B60C93FA7F8}"/>
              </a:ext>
            </a:extLst>
          </p:cNvPr>
          <p:cNvSpPr txBox="1"/>
          <p:nvPr/>
        </p:nvSpPr>
        <p:spPr>
          <a:xfrm>
            <a:off x="-1" y="6733340"/>
            <a:ext cx="37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A39C816F-E6EE-75D4-292C-F14A600E28D1}"/>
              </a:ext>
            </a:extLst>
          </p:cNvPr>
          <p:cNvSpPr txBox="1"/>
          <p:nvPr/>
        </p:nvSpPr>
        <p:spPr>
          <a:xfrm>
            <a:off x="2971542" y="2599805"/>
            <a:ext cx="113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IF5A [-]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">
            <a:extLst>
              <a:ext uri="{FF2B5EF4-FFF2-40B4-BE49-F238E27FC236}">
                <a16:creationId xmlns:a16="http://schemas.microsoft.com/office/drawing/2014/main" id="{97FB73BC-F638-2FA5-1286-BC83C0C290A3}"/>
              </a:ext>
            </a:extLst>
          </p:cNvPr>
          <p:cNvSpPr txBox="1"/>
          <p:nvPr/>
        </p:nvSpPr>
        <p:spPr>
          <a:xfrm>
            <a:off x="2480310" y="5581349"/>
            <a:ext cx="2366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.5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eIF5A (</a:t>
            </a:r>
            <a:r>
              <a:rPr kumimoji="1"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">
            <a:extLst>
              <a:ext uri="{FF2B5EF4-FFF2-40B4-BE49-F238E27FC236}">
                <a16:creationId xmlns:a16="http://schemas.microsoft.com/office/drawing/2014/main" id="{228F455C-4F26-BFCD-5C05-1DAB396D6A4F}"/>
              </a:ext>
            </a:extLst>
          </p:cNvPr>
          <p:cNvSpPr txBox="1"/>
          <p:nvPr/>
        </p:nvSpPr>
        <p:spPr>
          <a:xfrm>
            <a:off x="2480310" y="8989731"/>
            <a:ext cx="24597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.5 </a:t>
            </a:r>
            <a:r>
              <a:rPr lang="el-GR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eIF5A (</a:t>
            </a:r>
            <a:r>
              <a:rPr kumimoji="1"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lys</a:t>
            </a:r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9C311F6E-63BA-9EB6-EA8A-6C9FE5F32FFE}"/>
              </a:ext>
            </a:extLst>
          </p:cNvPr>
          <p:cNvSpPr txBox="1"/>
          <p:nvPr/>
        </p:nvSpPr>
        <p:spPr>
          <a:xfrm>
            <a:off x="3537327" y="523035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0CEE889-EF6E-843B-9FFE-369405B11164}"/>
              </a:ext>
            </a:extLst>
          </p:cNvPr>
          <p:cNvSpPr txBox="1"/>
          <p:nvPr/>
        </p:nvSpPr>
        <p:spPr>
          <a:xfrm>
            <a:off x="3537327" y="3479694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6A2FE4B-91AA-314F-9922-7D957A788391}"/>
              </a:ext>
            </a:extLst>
          </p:cNvPr>
          <p:cNvSpPr txBox="1"/>
          <p:nvPr/>
        </p:nvSpPr>
        <p:spPr>
          <a:xfrm>
            <a:off x="3488703" y="6723250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228AD93-FAF9-CE30-0F5F-9BF3A1E4DD0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8970" y="917190"/>
            <a:ext cx="3076352" cy="1771767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9EF31E46-F370-4496-98F5-FD9023300B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5030" y="6951855"/>
            <a:ext cx="3303970" cy="1916709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881746FF-09A9-2E35-5A21-ED4D1384E7D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16622" y="971180"/>
            <a:ext cx="3102796" cy="1771767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1236A533-4650-AC83-885F-1F77518D295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10168" y="3740859"/>
            <a:ext cx="2890862" cy="1906899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86C59A39-1020-485D-8110-C6C6A8D65D9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10168" y="6951855"/>
            <a:ext cx="3102796" cy="191670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F175E827-BC8B-515E-E2CA-6DD02139D55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-1" y="3675712"/>
            <a:ext cx="3361742" cy="18822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12331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107">
            <a:extLst>
              <a:ext uri="{FF2B5EF4-FFF2-40B4-BE49-F238E27FC236}">
                <a16:creationId xmlns:a16="http://schemas.microsoft.com/office/drawing/2014/main" id="{F5CEEF7B-FE5B-E9C3-4864-0F69C08C9870}"/>
              </a:ext>
            </a:extLst>
          </p:cNvPr>
          <p:cNvSpPr/>
          <p:nvPr/>
        </p:nvSpPr>
        <p:spPr>
          <a:xfrm>
            <a:off x="162411" y="141527"/>
            <a:ext cx="28777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A9216CB-C63F-CF4F-1134-FF562AF4D5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9669" y="1556020"/>
            <a:ext cx="5410200" cy="2552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03188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107">
            <a:extLst>
              <a:ext uri="{FF2B5EF4-FFF2-40B4-BE49-F238E27FC236}">
                <a16:creationId xmlns:a16="http://schemas.microsoft.com/office/drawing/2014/main" id="{FBDBD8FB-9D8B-7A4B-A261-BA6EEE58F4E1}"/>
              </a:ext>
            </a:extLst>
          </p:cNvPr>
          <p:cNvSpPr/>
          <p:nvPr/>
        </p:nvSpPr>
        <p:spPr>
          <a:xfrm>
            <a:off x="162411" y="141527"/>
            <a:ext cx="28777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DA98FCB-EF2B-6420-497A-9BE65892A439}"/>
              </a:ext>
            </a:extLst>
          </p:cNvPr>
          <p:cNvSpPr txBox="1"/>
          <p:nvPr/>
        </p:nvSpPr>
        <p:spPr>
          <a:xfrm>
            <a:off x="207267" y="547316"/>
            <a:ext cx="37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EC869D9-6625-985C-0534-D4F2D867EAB7}"/>
              </a:ext>
            </a:extLst>
          </p:cNvPr>
          <p:cNvSpPr txBox="1"/>
          <p:nvPr/>
        </p:nvSpPr>
        <p:spPr>
          <a:xfrm>
            <a:off x="3260803" y="533166"/>
            <a:ext cx="37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CE9DE8F-58C2-646B-1B65-F2A91425FD71}"/>
              </a:ext>
            </a:extLst>
          </p:cNvPr>
          <p:cNvSpPr txBox="1"/>
          <p:nvPr/>
        </p:nvSpPr>
        <p:spPr>
          <a:xfrm>
            <a:off x="162411" y="2810774"/>
            <a:ext cx="37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09A3E08-7A3D-749D-1B71-32DB5B1FFCD1}"/>
              </a:ext>
            </a:extLst>
          </p:cNvPr>
          <p:cNvSpPr txBox="1"/>
          <p:nvPr/>
        </p:nvSpPr>
        <p:spPr>
          <a:xfrm>
            <a:off x="3337979" y="2793614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007A617-4ABB-5D5A-D05E-86A355535539}"/>
              </a:ext>
            </a:extLst>
          </p:cNvPr>
          <p:cNvSpPr txBox="1"/>
          <p:nvPr/>
        </p:nvSpPr>
        <p:spPr>
          <a:xfrm>
            <a:off x="150622" y="5012878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592C275-C220-7504-6925-A7A7A3001AA5}"/>
              </a:ext>
            </a:extLst>
          </p:cNvPr>
          <p:cNvSpPr txBox="1"/>
          <p:nvPr/>
        </p:nvSpPr>
        <p:spPr>
          <a:xfrm>
            <a:off x="3446202" y="5057482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6FB6CA9-B15E-9B17-7362-44B666C83F2A}"/>
              </a:ext>
            </a:extLst>
          </p:cNvPr>
          <p:cNvSpPr txBox="1"/>
          <p:nvPr/>
        </p:nvSpPr>
        <p:spPr>
          <a:xfrm>
            <a:off x="130548" y="7420775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14A35AF-9614-1FEE-3C85-94A6866C6E1E}"/>
              </a:ext>
            </a:extLst>
          </p:cNvPr>
          <p:cNvSpPr txBox="1"/>
          <p:nvPr/>
        </p:nvSpPr>
        <p:spPr>
          <a:xfrm>
            <a:off x="3393130" y="7403301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96F01D3F-DEF9-7E74-A0C1-8DCB28FC5B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860439"/>
            <a:ext cx="3308570" cy="1976292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556EE98A-6A2C-7D3E-CA50-168F0B9DD6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6397" y="860439"/>
            <a:ext cx="3020427" cy="1856593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06ECD24D-42E5-9D66-2221-8556BE7B7F6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7310" y="3225810"/>
            <a:ext cx="3195927" cy="1856593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D986007C-65F3-E367-4CE9-003E7293ED8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98808" y="3184685"/>
            <a:ext cx="3308570" cy="1938841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20FEC7BD-1BBF-584F-171F-AF10F96116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6125" y="5363244"/>
            <a:ext cx="3195674" cy="1861828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1C86C5AD-9F26-8BE1-8B8B-2449622E363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11799" y="5320670"/>
            <a:ext cx="3429000" cy="194697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73B13626-82EA-E155-A143-8F41A9D35F9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7267" y="7817670"/>
            <a:ext cx="3238935" cy="1991991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A5D59266-2E42-02CA-58C9-CCD2CB8C66C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398808" y="7794372"/>
            <a:ext cx="3429000" cy="20152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90407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1F65D24-45C2-83E9-8F4F-7500AE126CB1}"/>
              </a:ext>
            </a:extLst>
          </p:cNvPr>
          <p:cNvSpPr txBox="1"/>
          <p:nvPr/>
        </p:nvSpPr>
        <p:spPr>
          <a:xfrm>
            <a:off x="0" y="484811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4897DB9-3E7B-4612-EBF5-32C47C8E5DF9}"/>
              </a:ext>
            </a:extLst>
          </p:cNvPr>
          <p:cNvSpPr txBox="1"/>
          <p:nvPr/>
        </p:nvSpPr>
        <p:spPr>
          <a:xfrm>
            <a:off x="3429000" y="484811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A738722-C2D1-4A7E-D0E4-816BD4877E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469" y="864233"/>
            <a:ext cx="3245531" cy="183244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63A120F-2E14-0ACE-2FFA-5EB142F3573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94233" y="864232"/>
            <a:ext cx="3263767" cy="183245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9D60B323-5A22-D538-FCDD-F729DCF2F0DB}"/>
              </a:ext>
            </a:extLst>
          </p:cNvPr>
          <p:cNvSpPr txBox="1"/>
          <p:nvPr/>
        </p:nvSpPr>
        <p:spPr>
          <a:xfrm>
            <a:off x="-42168" y="2886393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8A185A75-EFEE-A871-A01C-FF32D12965EA}"/>
              </a:ext>
            </a:extLst>
          </p:cNvPr>
          <p:cNvSpPr txBox="1"/>
          <p:nvPr/>
        </p:nvSpPr>
        <p:spPr>
          <a:xfrm>
            <a:off x="3386832" y="2886393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55DBDD7B-E756-4593-3006-C83A4E1D4E3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5616" y="3265815"/>
            <a:ext cx="3141216" cy="1846154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A5624FF9-6077-A71A-B664-BD86AF6D7A3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55508" y="3247446"/>
            <a:ext cx="3141216" cy="1864523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AFE42058-8238-9A25-5D4F-66BF4D122A78}"/>
              </a:ext>
            </a:extLst>
          </p:cNvPr>
          <p:cNvSpPr txBox="1"/>
          <p:nvPr/>
        </p:nvSpPr>
        <p:spPr>
          <a:xfrm>
            <a:off x="-70223" y="5176215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30C40C1-3AE0-0BEC-8990-268171238761}"/>
              </a:ext>
            </a:extLst>
          </p:cNvPr>
          <p:cNvSpPr txBox="1"/>
          <p:nvPr/>
        </p:nvSpPr>
        <p:spPr>
          <a:xfrm>
            <a:off x="3358777" y="5176215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2C55B756-E041-0197-8628-53A7412CC37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3469" y="5778573"/>
            <a:ext cx="3141216" cy="1793706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8F78E257-F7B6-727B-7424-3C193EAC16E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05702" y="5707757"/>
            <a:ext cx="3191022" cy="186452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CEDDAE59-F729-4589-F3FE-3B7E8AB296A5}"/>
              </a:ext>
            </a:extLst>
          </p:cNvPr>
          <p:cNvSpPr txBox="1"/>
          <p:nvPr/>
        </p:nvSpPr>
        <p:spPr>
          <a:xfrm>
            <a:off x="-5133074" y="-3570346"/>
            <a:ext cx="8727307" cy="21419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1000"/>
              </a:spcAft>
            </a:pP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4. The time courses of readthrough assays in Figure 8. The 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were collected after 1.5hr and 3hr reaction. (A) The 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native aa-tRNAs (7.2 </a:t>
            </a:r>
            <a:r>
              <a:rPr lang="el-GR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the absence of eIF5A (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5 mM Mg</a:t>
            </a:r>
            <a:r>
              <a:rPr lang="en" altLang="zh-CN" sz="10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B) without eRF1. (C) The 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native aa-tRNAs (7.2 </a:t>
            </a:r>
            <a:r>
              <a:rPr lang="el-GR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presence of 2.5 </a:t>
            </a:r>
            <a:r>
              <a:rPr lang="el-GR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5 mM Mg</a:t>
            </a:r>
            <a:r>
              <a:rPr lang="en" altLang="zh-CN" sz="10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D) without eRF1. (E) The 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native aa-tRNAs (7.2 </a:t>
            </a:r>
            <a:r>
              <a:rPr lang="el-GR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the absence of 2.5 </a:t>
            </a:r>
            <a:r>
              <a:rPr lang="el-GR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9 mM Mg</a:t>
            </a:r>
            <a:r>
              <a:rPr lang="en" altLang="zh-CN" sz="10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F) without eRF1. (G) The 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native aa-tRNAs (7.2 </a:t>
            </a:r>
            <a:r>
              <a:rPr lang="el-GR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presence of 2.5 </a:t>
            </a:r>
            <a:r>
              <a:rPr lang="el-GR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9 mM Mg</a:t>
            </a:r>
            <a:r>
              <a:rPr lang="en" altLang="zh-CN" sz="10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H) without eRF1. (I) The 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VT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a-tRNAs (14.4 </a:t>
            </a:r>
            <a:r>
              <a:rPr lang="el-GR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presence of 2.5 </a:t>
            </a:r>
            <a:r>
              <a:rPr lang="el-GR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5 mM Mg</a:t>
            </a:r>
            <a:r>
              <a:rPr lang="en" altLang="zh-CN" sz="10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J) without eRF1. (K) The 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VT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a-tRNAs (14.4 </a:t>
            </a:r>
            <a:r>
              <a:rPr lang="el-GR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absence of eIF5A (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9 mM Mg</a:t>
            </a:r>
            <a:r>
              <a:rPr lang="en" altLang="zh-CN" sz="10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L) without eRF1. (M) The 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nanoluciferase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ctivities in the context of 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VT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a-tRNAs (14.4 </a:t>
            </a:r>
            <a:r>
              <a:rPr lang="el-GR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) in presence of 2.5 </a:t>
            </a:r>
            <a:r>
              <a:rPr lang="el-GR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 eIF5A (</a:t>
            </a:r>
            <a:r>
              <a:rPr lang="en" altLang="zh-CN" sz="10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p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at the 9 mM Mg</a:t>
            </a:r>
            <a:r>
              <a:rPr lang="en" altLang="zh-CN" sz="10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" altLang="zh-CN" sz="1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with eRF1 or (N) without eRF1. </a:t>
            </a:r>
            <a:endParaRPr lang="en" altLang="zh-CN" sz="1000" dirty="0">
              <a:effectLst/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17648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107">
            <a:extLst>
              <a:ext uri="{FF2B5EF4-FFF2-40B4-BE49-F238E27FC236}">
                <a16:creationId xmlns:a16="http://schemas.microsoft.com/office/drawing/2014/main" id="{EF73BBEA-357E-60F5-956F-550943122188}"/>
              </a:ext>
            </a:extLst>
          </p:cNvPr>
          <p:cNvSpPr/>
          <p:nvPr/>
        </p:nvSpPr>
        <p:spPr>
          <a:xfrm>
            <a:off x="162411" y="141527"/>
            <a:ext cx="28777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118CBEC-D8A9-B068-62A9-B75DBB3D91AF}"/>
              </a:ext>
            </a:extLst>
          </p:cNvPr>
          <p:cNvSpPr txBox="1"/>
          <p:nvPr/>
        </p:nvSpPr>
        <p:spPr>
          <a:xfrm>
            <a:off x="207267" y="683501"/>
            <a:ext cx="37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EB257A8-9A5B-0899-2303-3FA630062DB5}"/>
              </a:ext>
            </a:extLst>
          </p:cNvPr>
          <p:cNvSpPr txBox="1"/>
          <p:nvPr/>
        </p:nvSpPr>
        <p:spPr>
          <a:xfrm>
            <a:off x="3670709" y="713806"/>
            <a:ext cx="37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F225792-712F-AFD7-B864-ED9D406F2B38}"/>
              </a:ext>
            </a:extLst>
          </p:cNvPr>
          <p:cNvSpPr txBox="1"/>
          <p:nvPr/>
        </p:nvSpPr>
        <p:spPr>
          <a:xfrm>
            <a:off x="217310" y="2880840"/>
            <a:ext cx="37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FB72867-EFE5-B63E-19DE-F21656C5288B}"/>
              </a:ext>
            </a:extLst>
          </p:cNvPr>
          <p:cNvSpPr txBox="1"/>
          <p:nvPr/>
        </p:nvSpPr>
        <p:spPr>
          <a:xfrm>
            <a:off x="3666802" y="2839067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53DCC6D-03A8-2BBA-0C82-F80B6855BBE9}"/>
              </a:ext>
            </a:extLst>
          </p:cNvPr>
          <p:cNvSpPr txBox="1"/>
          <p:nvPr/>
        </p:nvSpPr>
        <p:spPr>
          <a:xfrm>
            <a:off x="150622" y="5193667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D44DE8B-BECB-0CD4-1192-A8B7478ABE13}"/>
              </a:ext>
            </a:extLst>
          </p:cNvPr>
          <p:cNvSpPr txBox="1"/>
          <p:nvPr/>
        </p:nvSpPr>
        <p:spPr>
          <a:xfrm>
            <a:off x="3803036" y="5193667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5266789-06D8-5F58-9413-AF97F4689B1E}"/>
              </a:ext>
            </a:extLst>
          </p:cNvPr>
          <p:cNvSpPr txBox="1"/>
          <p:nvPr/>
        </p:nvSpPr>
        <p:spPr>
          <a:xfrm>
            <a:off x="123376" y="7436487"/>
            <a:ext cx="491232" cy="37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D400179B-88D5-44B6-A286-72DE737E17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6963" y="1027573"/>
            <a:ext cx="2742223" cy="1837452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C7B82493-D5DE-8EB0-3C15-5C567377F2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91805" y="1118046"/>
            <a:ext cx="2986160" cy="1885665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8411AB74-6920-F027-3474-87FC88DEE83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7267" y="3331295"/>
            <a:ext cx="2877711" cy="1862372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74108512-1A53-3999-7FA9-4A283526E4C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91805" y="3302171"/>
            <a:ext cx="3084976" cy="1807814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9A232125-29C8-B4E1-0BFC-068A950962E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91805" y="5573089"/>
            <a:ext cx="3084976" cy="1807814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39665B45-D5C8-E615-4BC6-44AF1F4A961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7267" y="7847335"/>
            <a:ext cx="2934356" cy="1689987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10D1B440-12AD-DE62-96E6-6C71B551462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7267" y="5573089"/>
            <a:ext cx="3087312" cy="17629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91336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E3089384-FB03-A1DA-A5B6-FD85650068A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2965" y="981878"/>
            <a:ext cx="5132070" cy="363918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435BEA2E-B195-78DE-5F4B-35FE4AB6F172}"/>
              </a:ext>
            </a:extLst>
          </p:cNvPr>
          <p:cNvSpPr txBox="1"/>
          <p:nvPr/>
        </p:nvSpPr>
        <p:spPr>
          <a:xfrm>
            <a:off x="801861" y="704879"/>
            <a:ext cx="46027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able 1 The sequences of IVT tRN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D56730C3-F06E-DC8C-6771-E6073C40A30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1861" y="5393523"/>
            <a:ext cx="5258343" cy="3693328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EF430CF-756D-6881-C602-ABA1B1D3BD55}"/>
              </a:ext>
            </a:extLst>
          </p:cNvPr>
          <p:cNvSpPr txBox="1"/>
          <p:nvPr/>
        </p:nvSpPr>
        <p:spPr>
          <a:xfrm>
            <a:off x="723265" y="5116524"/>
            <a:ext cx="59799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able 2 The sequences of mRNA and primer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8488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17</TotalTime>
  <Words>1167</Words>
  <Application>Microsoft Office PowerPoint</Application>
  <PresentationFormat>A4 纸张(210x297 毫米)</PresentationFormat>
  <Paragraphs>71</Paragraphs>
  <Slides>7</Slides>
  <Notes>6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3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User</dc:creator>
  <cp:lastModifiedBy>e16595</cp:lastModifiedBy>
  <cp:revision>78</cp:revision>
  <cp:lastPrinted>2023-02-02T00:33:20Z</cp:lastPrinted>
  <dcterms:created xsi:type="dcterms:W3CDTF">2022-09-01T01:20:32Z</dcterms:created>
  <dcterms:modified xsi:type="dcterms:W3CDTF">2025-09-11T11:59:26Z</dcterms:modified>
</cp:coreProperties>
</file>